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1" r:id="rId3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A4BE2D2-87CD-4F32-996F-D23023E7E8E3}" v="4" dt="2018-12-16T18:45:50.8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16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vian Ding" userId="cbf6fa2bb0a17f37" providerId="LiveId" clId="{8A4BE2D2-87CD-4F32-996F-D23023E7E8E3}"/>
    <pc:docChg chg="undo redo modSld">
      <pc:chgData name="Vivian Ding" userId="cbf6fa2bb0a17f37" providerId="LiveId" clId="{8A4BE2D2-87CD-4F32-996F-D23023E7E8E3}" dt="2018-12-16T18:47:17.779" v="32" actId="2"/>
      <pc:docMkLst>
        <pc:docMk/>
      </pc:docMkLst>
      <pc:sldChg chg="modSp">
        <pc:chgData name="Vivian Ding" userId="cbf6fa2bb0a17f37" providerId="LiveId" clId="{8A4BE2D2-87CD-4F32-996F-D23023E7E8E3}" dt="2018-12-16T18:47:10.155" v="31" actId="790"/>
        <pc:sldMkLst>
          <pc:docMk/>
          <pc:sldMk cId="243536764" sldId="259"/>
        </pc:sldMkLst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7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8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9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0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1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2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3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4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5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6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7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8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19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0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1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2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3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4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5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6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7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8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29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30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31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32" creationId="{00000000-0000-0000-0000-000000000000}"/>
          </ac:spMkLst>
        </pc:spChg>
        <pc:spChg chg="mod">
          <ac:chgData name="Vivian Ding" userId="cbf6fa2bb0a17f37" providerId="LiveId" clId="{8A4BE2D2-87CD-4F32-996F-D23023E7E8E3}" dt="2018-12-16T18:47:10.155" v="31" actId="790"/>
          <ac:spMkLst>
            <pc:docMk/>
            <pc:sldMk cId="243536764" sldId="259"/>
            <ac:spMk id="33" creationId="{00000000-0000-0000-0000-000000000000}"/>
          </ac:spMkLst>
        </pc:spChg>
      </pc:sldChg>
      <pc:sldChg chg="modSp">
        <pc:chgData name="Vivian Ding" userId="cbf6fa2bb0a17f37" providerId="LiveId" clId="{8A4BE2D2-87CD-4F32-996F-D23023E7E8E3}" dt="2018-12-16T18:47:17.779" v="32" actId="2"/>
        <pc:sldMkLst>
          <pc:docMk/>
          <pc:sldMk cId="2771726079" sldId="261"/>
        </pc:sldMkLst>
        <pc:spChg chg="mod">
          <ac:chgData name="Vivian Ding" userId="cbf6fa2bb0a17f37" providerId="LiveId" clId="{8A4BE2D2-87CD-4F32-996F-D23023E7E8E3}" dt="2018-12-16T18:47:17.779" v="32" actId="2"/>
          <ac:spMkLst>
            <pc:docMk/>
            <pc:sldMk cId="2771726079" sldId="261"/>
            <ac:spMk id="7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D413D3-0475-4A8E-9F57-E658986FBAE3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A15F85-55A8-408C-8362-BAB49CC8B5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3963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A15F85-55A8-408C-8362-BAB49CC8B57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99714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B19110-B912-4CD1-93DD-F26A47B64F8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891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3891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599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624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966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0118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9316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0943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200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489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9552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8341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C1556-8DF5-4EF5-B1A3-7C6A2E6D97CE}" type="datetimeFigureOut">
              <a:rPr kumimoji="1" lang="ja-JP" altLang="en-US" smtClean="0"/>
              <a:t>2018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60D6D-E6E3-43DF-A300-1804446196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257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776" y="260648"/>
            <a:ext cx="3778911" cy="28071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4208" y="2982069"/>
            <a:ext cx="3399960" cy="2751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テキスト ボックス 6"/>
          <p:cNvSpPr txBox="1"/>
          <p:nvPr/>
        </p:nvSpPr>
        <p:spPr>
          <a:xfrm>
            <a:off x="3347864" y="5705474"/>
            <a:ext cx="2666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principal component (73.0%)</a:t>
            </a: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842079" y="2828180"/>
            <a:ext cx="28664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principal component (15.3%)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908690" y="6165304"/>
            <a:ext cx="56886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Principal component analysis-Y of the taste attribute profiles. </a:t>
            </a:r>
          </a:p>
          <a:p>
            <a:pPr marL="342900" indent="-342900">
              <a:buAutoNum type="alphaUcParenR"/>
            </a:pPr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ore plot. Numbers indicated the fish specimens in Table S3. B) </a:t>
            </a:r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ading plot.</a:t>
            </a:r>
          </a:p>
        </p:txBody>
      </p:sp>
      <p:sp>
        <p:nvSpPr>
          <p:cNvPr id="10" name="正方形/長方形 9"/>
          <p:cNvSpPr/>
          <p:nvPr/>
        </p:nvSpPr>
        <p:spPr>
          <a:xfrm>
            <a:off x="5366288" y="1988840"/>
            <a:ext cx="1293944" cy="7848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 </a:t>
            </a:r>
            <a:r>
              <a:rPr lang="en-GB" altLang="ja-JP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modestus</a:t>
            </a:r>
          </a:p>
          <a:p>
            <a:r>
              <a:rPr lang="en-GB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■ </a:t>
            </a:r>
            <a:r>
              <a:rPr lang="en-GB" altLang="ja-JP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marmoratus</a:t>
            </a:r>
          </a:p>
          <a:p>
            <a:r>
              <a:rPr lang="en-GB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▲ </a:t>
            </a:r>
            <a:r>
              <a:rPr lang="en-GB" altLang="ja-JP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 japonicus </a:t>
            </a:r>
            <a:r>
              <a:rPr lang="en-GB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ale)</a:t>
            </a:r>
          </a:p>
          <a:p>
            <a:r>
              <a:rPr lang="en-GB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▼ </a:t>
            </a:r>
            <a:r>
              <a:rPr lang="en-GB" altLang="ja-JP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 japonicus </a:t>
            </a:r>
            <a:r>
              <a:rPr lang="en-GB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emale)</a:t>
            </a:r>
          </a:p>
          <a:p>
            <a:r>
              <a:rPr lang="en-GB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◆ </a:t>
            </a:r>
            <a:r>
              <a:rPr lang="en-GB" altLang="ja-JP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major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814446" y="142380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174486" y="112101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662318" y="148478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839870" y="16288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310390" y="118571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139952" y="63172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122578" y="169529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801398" y="9919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004048" y="185585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958462" y="112474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169550" y="155679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670593" y="192255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593486" y="178384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211960" y="908720"/>
            <a:ext cx="332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283968" y="135180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692140" y="3224009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tiness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510758" y="4797152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rness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999585" y="4080663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ic bitterness</a:t>
            </a:r>
            <a:endParaRPr kumimoji="1" lang="en-GB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779912" y="3573016"/>
            <a:ext cx="61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ritant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274233" y="4304129"/>
            <a:ext cx="801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tterness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283968" y="4658652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ringency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419872" y="502420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mami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263140" y="5024208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hness</a:t>
            </a:r>
          </a:p>
        </p:txBody>
      </p:sp>
    </p:spTree>
    <p:extLst>
      <p:ext uri="{BB962C8B-B14F-4D97-AF65-F5344CB8AC3E}">
        <p14:creationId xmlns:p14="http://schemas.microsoft.com/office/powerpoint/2010/main" val="243536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https://www.metaboanalyst.ca/MetaboAnalyst/resources/users/guest1373182655067689872tmp/heatmap_5_dpi7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116632"/>
            <a:ext cx="5112568" cy="5112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正方形/長方形 3"/>
          <p:cNvSpPr/>
          <p:nvPr/>
        </p:nvSpPr>
        <p:spPr>
          <a:xfrm>
            <a:off x="5652120" y="548680"/>
            <a:ext cx="792088" cy="45365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580112" y="477252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300192" y="1844824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6660232" y="566827"/>
            <a:ext cx="336642" cy="538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588224" y="459105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738022" y="5505532"/>
            <a:ext cx="492221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Heatmap based on hierarchical clustering analysis </a:t>
            </a:r>
            <a:r>
              <a:rPr kumimoji="1"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sualisation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differential metabolites and taste attributes in fish specie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lour denotes the VIP values based on PLS-DA of metabolites and taste attributes, from the highest (red) to the lowest (blue).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 of lower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dg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the fish specimens in Table S3.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580112" y="652046"/>
            <a:ext cx="71045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e-4TMS(4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580112" y="796062"/>
            <a:ext cx="90120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nose-meto-4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580112" y="940078"/>
            <a:ext cx="8499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xose-meto-4TMS1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580112" y="1084094"/>
            <a:ext cx="8499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xose-meto-4TMS2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580112" y="1228110"/>
            <a:ext cx="80342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lose-meto-4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580112" y="1372126"/>
            <a:ext cx="79861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e-meto-4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580112" y="1516142"/>
            <a:ext cx="70083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ic bitternes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580112" y="1660158"/>
            <a:ext cx="4138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mami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580112" y="1804174"/>
            <a:ext cx="6495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ine-3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580112" y="1967935"/>
            <a:ext cx="6286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ne-2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580112" y="2092206"/>
            <a:ext cx="7906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otaurine-3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580112" y="2236222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ritant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580112" y="2380238"/>
            <a:ext cx="87556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ose-meto-5TMS(2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580112" y="2524254"/>
            <a:ext cx="9573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nose</a:t>
            </a:r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eto-5TMS(2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580112" y="2668270"/>
            <a:ext cx="9765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lactose-meto-5TMS(2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580112" y="2812286"/>
            <a:ext cx="9268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-meto-5TMS(1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580112" y="2956302"/>
            <a:ext cx="7280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icose-5TMS(4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580112" y="3100318"/>
            <a:ext cx="9573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nose</a:t>
            </a:r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eto-5TMS(1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580112" y="3244334"/>
            <a:ext cx="9268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-meto-5TMS(2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580112" y="3417064"/>
            <a:ext cx="9765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lactose-meto-5TMS(1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580112" y="3573016"/>
            <a:ext cx="4571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tines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580112" y="3717032"/>
            <a:ext cx="7729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gatose-5TMS(5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5580112" y="3861048"/>
            <a:ext cx="75854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acinamide-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580112" y="4005064"/>
            <a:ext cx="10695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erol 3-phosphate-4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580112" y="4149080"/>
            <a:ext cx="7248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atinine-3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580112" y="4293096"/>
            <a:ext cx="8996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ric acid-3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580112" y="4437112"/>
            <a:ext cx="7425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ic acid-2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5580112" y="4581128"/>
            <a:ext cx="4635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rnes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580112" y="4725144"/>
            <a:ext cx="7489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-5TMS(1)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580112" y="4869160"/>
            <a:ext cx="8402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ylalanine-2TMS</a:t>
            </a:r>
            <a:endParaRPr kumimoji="1" lang="ja-JP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2195736" y="5085184"/>
            <a:ext cx="3576095" cy="144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2339752" y="5013176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555776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756157" y="501317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956538" y="501317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3172562" y="501317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455912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671936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887960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4067944" y="501317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4304329" y="501317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572000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4788024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4999126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5220072" y="5013176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5404810" y="501317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17260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3</TotalTime>
  <Words>217</Words>
  <Application>Microsoft Office PowerPoint</Application>
  <PresentationFormat>画面に合わせる (4:3)</PresentationFormat>
  <Paragraphs>83</Paragraphs>
  <Slides>2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県立広島大学</dc:creator>
  <cp:lastModifiedBy>県立広島大学</cp:lastModifiedBy>
  <cp:revision>37</cp:revision>
  <cp:lastPrinted>2018-12-13T07:44:19Z</cp:lastPrinted>
  <dcterms:created xsi:type="dcterms:W3CDTF">2018-03-01T07:37:20Z</dcterms:created>
  <dcterms:modified xsi:type="dcterms:W3CDTF">2018-12-17T11:32:46Z</dcterms:modified>
</cp:coreProperties>
</file>